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327"/>
  </p:normalViewPr>
  <p:slideViewPr>
    <p:cSldViewPr snapToGrid="0" snapToObjects="1">
      <p:cViewPr varScale="1">
        <p:scale>
          <a:sx n="124" d="100"/>
          <a:sy n="124" d="100"/>
        </p:scale>
        <p:origin x="54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36893BA-D637-AE4B-AD73-FF92FC6713AD}" type="datetimeFigureOut">
              <a:rPr lang="en-US" smtClean="0"/>
              <a:t>5/4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4E41F2C-517C-C94F-AE35-241961119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78612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Google Shape;78;p2:notes"/>
          <p:cNvSpPr txBox="1">
            <a:spLocks noGrp="1"/>
          </p:cNvSpPr>
          <p:nvPr>
            <p:ph type="body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79" name="Google Shape;79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3E1A55-0343-2143-82A5-445BD8A32FA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4572D21-F73F-3A4E-942D-12490F0E356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328C09-EB77-A742-B1D7-47177669AF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505D0-96D5-4349-A1D1-681019D673D3}" type="datetimeFigureOut">
              <a:rPr lang="en-US" smtClean="0"/>
              <a:t>5/4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9D73BC-9BF3-AD46-8871-7D0CCDDAFC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6B25FB-BF41-6048-85B1-A11FF54FE1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E068E-69D6-6848-AD98-5D9C13A80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97584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FCC48F-A60C-CE40-8C2F-3D011F29F0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9B1B552-D305-D546-8981-E20CE50FD75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51C756-85AE-9740-8E97-9E7E2DBC7C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505D0-96D5-4349-A1D1-681019D673D3}" type="datetimeFigureOut">
              <a:rPr lang="en-US" smtClean="0"/>
              <a:t>5/4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536F56-A579-DB4C-8EB9-27A3CF40F8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B57B45-6145-CF41-9E9F-98A269A6AB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E068E-69D6-6848-AD98-5D9C13A80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11266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1312FEE-7E01-0B43-9235-0699A0AFDF0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38058A2-F818-1E4B-BD23-2DC2D0F12D8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03559E-A681-E54C-BC1A-63C82E4080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505D0-96D5-4349-A1D1-681019D673D3}" type="datetimeFigureOut">
              <a:rPr lang="en-US" smtClean="0"/>
              <a:t>5/4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BCDBDD-DA3B-E241-8A1A-0EBFB172EE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694C65-6F33-4D46-A47D-B825BE0591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E068E-69D6-6848-AD98-5D9C13A80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425181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&amp; Bullets" type="tx">
  <p:cSld name="Title &amp; Bullets">
    <p:spTree>
      <p:nvGrpSpPr>
        <p:cNvPr id="1" name="Shape 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Google Shape;15;p5"/>
          <p:cNvSpPr txBox="1">
            <a:spLocks noGrp="1"/>
          </p:cNvSpPr>
          <p:nvPr>
            <p:ph type="title"/>
          </p:nvPr>
        </p:nvSpPr>
        <p:spPr>
          <a:xfrm>
            <a:off x="603250" y="1262062"/>
            <a:ext cx="10985501" cy="53743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7075" tIns="27075" rIns="27075" bIns="27075" anchor="t" anchorCtr="0">
            <a:normAutofit/>
          </a:bodyPr>
          <a:lstStyle>
            <a:lvl1pPr lvl="0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000"/>
              <a:buFont typeface="Helvetica Neue"/>
              <a:buNone/>
              <a:defRPr sz="4219"/>
            </a:lvl1pPr>
            <a:lvl2pPr lvl="1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2pPr>
            <a:lvl3pPr lvl="2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3pPr>
            <a:lvl4pPr lvl="3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4pPr>
            <a:lvl5pPr lvl="4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5pPr>
            <a:lvl6pPr lvl="5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6pPr>
            <a:lvl7pPr lvl="6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7pPr>
            <a:lvl8pPr lvl="7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8pPr>
            <a:lvl9pPr lvl="8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9pPr>
          </a:lstStyle>
          <a:p>
            <a:endParaRPr/>
          </a:p>
        </p:txBody>
      </p:sp>
      <p:sp>
        <p:nvSpPr>
          <p:cNvPr id="16" name="Google Shape;16;p5"/>
          <p:cNvSpPr txBox="1">
            <a:spLocks noGrp="1"/>
          </p:cNvSpPr>
          <p:nvPr>
            <p:ph type="body" idx="1"/>
          </p:nvPr>
        </p:nvSpPr>
        <p:spPr>
          <a:xfrm>
            <a:off x="603250" y="1747110"/>
            <a:ext cx="10985501" cy="35054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4375" tIns="24375" rIns="24375" bIns="24375" anchor="t" anchorCtr="0">
            <a:normAutofit/>
          </a:bodyPr>
          <a:lstStyle>
            <a:lvl1pPr marL="321457" lvl="0" indent="-160729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964"/>
              <a:buFont typeface="Helvetica Neue"/>
              <a:buNone/>
              <a:defRPr sz="2084"/>
            </a:lvl1pPr>
            <a:lvl2pPr marL="642915" lvl="1" indent="-160729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2pPr>
            <a:lvl3pPr marL="964372" lvl="2" indent="-160729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3pPr>
            <a:lvl4pPr marL="1285829" lvl="3" indent="-160729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4pPr>
            <a:lvl5pPr marL="1607287" lvl="4" indent="-160729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5pPr>
            <a:lvl6pPr marL="1928744" lvl="5" indent="-160729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6pPr>
            <a:lvl7pPr marL="2250201" lvl="6" indent="-160729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7pPr>
            <a:lvl8pPr marL="2571659" lvl="7" indent="-160729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8pPr>
            <a:lvl9pPr marL="2893116" lvl="8" indent="-160729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5"/>
          <p:cNvSpPr txBox="1">
            <a:spLocks noGrp="1"/>
          </p:cNvSpPr>
          <p:nvPr>
            <p:ph type="body" idx="2"/>
          </p:nvPr>
        </p:nvSpPr>
        <p:spPr>
          <a:xfrm>
            <a:off x="603250" y="2450439"/>
            <a:ext cx="10985501" cy="309600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7075" tIns="27075" rIns="27075" bIns="27075" anchor="t" anchorCtr="0">
            <a:normAutofit/>
          </a:bodyPr>
          <a:lstStyle>
            <a:lvl1pPr marL="321457" lvl="0" indent="-347442" algn="l">
              <a:lnSpc>
                <a:spcPct val="90000"/>
              </a:lnSpc>
              <a:spcBef>
                <a:spcPts val="2250"/>
              </a:spcBef>
              <a:spcAft>
                <a:spcPts val="0"/>
              </a:spcAft>
              <a:buClr>
                <a:srgbClr val="000000"/>
              </a:buClr>
              <a:buSzPts val="4182"/>
              <a:buFont typeface="Helvetica Neue"/>
              <a:buChar char="•"/>
              <a:defRPr sz="2391" b="0"/>
            </a:lvl1pPr>
            <a:lvl2pPr marL="642915" lvl="1" indent="-347442" algn="l">
              <a:lnSpc>
                <a:spcPct val="90000"/>
              </a:lnSpc>
              <a:spcBef>
                <a:spcPts val="2250"/>
              </a:spcBef>
              <a:spcAft>
                <a:spcPts val="0"/>
              </a:spcAft>
              <a:buClr>
                <a:srgbClr val="000000"/>
              </a:buClr>
              <a:buSzPts val="4182"/>
              <a:buFont typeface="Helvetica Neue"/>
              <a:buChar char="•"/>
              <a:defRPr sz="2391" b="0"/>
            </a:lvl2pPr>
            <a:lvl3pPr marL="964372" lvl="2" indent="-347442" algn="l">
              <a:lnSpc>
                <a:spcPct val="90000"/>
              </a:lnSpc>
              <a:spcBef>
                <a:spcPts val="2250"/>
              </a:spcBef>
              <a:spcAft>
                <a:spcPts val="0"/>
              </a:spcAft>
              <a:buClr>
                <a:srgbClr val="000000"/>
              </a:buClr>
              <a:buSzPts val="4182"/>
              <a:buFont typeface="Helvetica Neue"/>
              <a:buChar char="•"/>
              <a:defRPr sz="2391" b="0"/>
            </a:lvl3pPr>
            <a:lvl4pPr marL="1285829" lvl="3" indent="-347442" algn="l">
              <a:lnSpc>
                <a:spcPct val="90000"/>
              </a:lnSpc>
              <a:spcBef>
                <a:spcPts val="2250"/>
              </a:spcBef>
              <a:spcAft>
                <a:spcPts val="0"/>
              </a:spcAft>
              <a:buClr>
                <a:srgbClr val="000000"/>
              </a:buClr>
              <a:buSzPts val="4182"/>
              <a:buFont typeface="Helvetica Neue"/>
              <a:buChar char="•"/>
              <a:defRPr sz="2391" b="0"/>
            </a:lvl4pPr>
            <a:lvl5pPr marL="1607287" lvl="4" indent="-347442" algn="l">
              <a:lnSpc>
                <a:spcPct val="90000"/>
              </a:lnSpc>
              <a:spcBef>
                <a:spcPts val="2250"/>
              </a:spcBef>
              <a:spcAft>
                <a:spcPts val="0"/>
              </a:spcAft>
              <a:buClr>
                <a:srgbClr val="000000"/>
              </a:buClr>
              <a:buSzPts val="4182"/>
              <a:buFont typeface="Helvetica Neue"/>
              <a:buChar char="•"/>
              <a:defRPr sz="2391" b="0"/>
            </a:lvl5pPr>
            <a:lvl6pPr marL="1928744" lvl="5" indent="-160729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6pPr>
            <a:lvl7pPr marL="2250201" lvl="6" indent="-160729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7pPr>
            <a:lvl8pPr marL="2571659" lvl="7" indent="-160729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8pPr>
            <a:lvl9pPr marL="2893116" lvl="8" indent="-160729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5"/>
          <p:cNvSpPr txBox="1">
            <a:spLocks noGrp="1"/>
          </p:cNvSpPr>
          <p:nvPr>
            <p:ph type="sldNum" idx="12"/>
          </p:nvPr>
        </p:nvSpPr>
        <p:spPr>
          <a:xfrm>
            <a:off x="5982084" y="5718514"/>
            <a:ext cx="221585" cy="18458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7075" tIns="27075" rIns="27075" bIns="27075" anchor="b" anchorCtr="0">
            <a:spAutoFit/>
          </a:bodyPr>
          <a:lstStyle>
            <a:lvl1pPr marL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844">
                <a:solidFill>
                  <a:srgbClr val="000000"/>
                </a:solidFill>
              </a:defRPr>
            </a:lvl1pPr>
            <a:lvl2pPr marL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844">
                <a:solidFill>
                  <a:srgbClr val="000000"/>
                </a:solidFill>
              </a:defRPr>
            </a:lvl2pPr>
            <a:lvl3pPr marL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844">
                <a:solidFill>
                  <a:srgbClr val="000000"/>
                </a:solidFill>
              </a:defRPr>
            </a:lvl3pPr>
            <a:lvl4pPr marL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844">
                <a:solidFill>
                  <a:srgbClr val="000000"/>
                </a:solidFill>
              </a:defRPr>
            </a:lvl4pPr>
            <a:lvl5pPr marL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844">
                <a:solidFill>
                  <a:srgbClr val="000000"/>
                </a:solidFill>
              </a:defRPr>
            </a:lvl5pPr>
            <a:lvl6pPr marL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844">
                <a:solidFill>
                  <a:srgbClr val="000000"/>
                </a:solidFill>
              </a:defRPr>
            </a:lvl6pPr>
            <a:lvl7pPr marL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844">
                <a:solidFill>
                  <a:srgbClr val="000000"/>
                </a:solidFill>
              </a:defRPr>
            </a:lvl7pPr>
            <a:lvl8pPr marL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844">
                <a:solidFill>
                  <a:srgbClr val="000000"/>
                </a:solidFill>
              </a:defRPr>
            </a:lvl8pPr>
            <a:lvl9pPr marL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Helvetica Neue"/>
              <a:buNone/>
              <a:defRPr sz="844">
                <a:solidFill>
                  <a:srgbClr val="000000"/>
                </a:solidFill>
              </a:defRPr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53249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6E0BAA-9071-EC49-B3D3-4A07793DFC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49A9A90-DEFF-7C4D-B415-3FD81477CAC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E5752D-0907-9B42-9AE7-C3C1842842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505D0-96D5-4349-A1D1-681019D673D3}" type="datetimeFigureOut">
              <a:rPr lang="en-US" smtClean="0"/>
              <a:t>5/4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9445BA-8CAD-DD4E-BDF5-2214C4900E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1731A3-403E-C245-A5F1-4F947F7DA3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E068E-69D6-6848-AD98-5D9C13A80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12775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2D480C-D33C-F24C-8E2D-983C54ECC3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B274684-5AC9-0149-92E7-CE87706FFC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A0DE10-63DE-6D47-8BA9-668FE97473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505D0-96D5-4349-A1D1-681019D673D3}" type="datetimeFigureOut">
              <a:rPr lang="en-US" smtClean="0"/>
              <a:t>5/4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395ACD-8836-BD4F-898F-6E6386DC2E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ED2112-02B6-394D-A077-421B4F467A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E068E-69D6-6848-AD98-5D9C13A80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54222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D3C4A5-F800-364C-AE2C-24152BC442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CA440DD-D1F9-0F48-9066-8988B0D484E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83F70D2-C0CF-6F40-BCC9-4FF9A74C517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7C26EC6-F40C-064D-9694-8F15B9DC54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505D0-96D5-4349-A1D1-681019D673D3}" type="datetimeFigureOut">
              <a:rPr lang="en-US" smtClean="0"/>
              <a:t>5/4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F26442-AB0D-8441-A9BE-995C9E26BE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69B907B-72AB-0A42-8629-7D3CDA4B36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E068E-69D6-6848-AD98-5D9C13A80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88501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C12002-89A4-664F-AA1D-6597071CF2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F3C5AB3-997B-D045-8E8F-7DBCABC61C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BC45394-720C-2442-A9B2-74A2581407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A8AAB17-94C7-2D45-9171-4DD6A2A3B7F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BBDEF22-C2C0-734E-853E-7FFA68DE18F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31EC337-DB68-6944-8EC6-5F27375107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505D0-96D5-4349-A1D1-681019D673D3}" type="datetimeFigureOut">
              <a:rPr lang="en-US" smtClean="0"/>
              <a:t>5/4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16B3A35-3114-CB4E-933D-F6849D4CBD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7829E8E-D880-3049-B50E-F3413A1269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E068E-69D6-6848-AD98-5D9C13A80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23553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7C90BF-E397-4F43-ABB3-1A3C39FD74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955903B-DD23-6542-B3CC-5F3A8DE04E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505D0-96D5-4349-A1D1-681019D673D3}" type="datetimeFigureOut">
              <a:rPr lang="en-US" smtClean="0"/>
              <a:t>5/4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D6F7C26-6A7E-964A-8029-C6E8801075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0FD596E-E90B-9240-A06F-717F2B3C6A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E068E-69D6-6848-AD98-5D9C13A80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42011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EA8354B-41AE-D045-865A-D3FF0DBBFF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505D0-96D5-4349-A1D1-681019D673D3}" type="datetimeFigureOut">
              <a:rPr lang="en-US" smtClean="0"/>
              <a:t>5/4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17D6F89-059E-9546-95D8-B6B6AFF10F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A1E6B76-5E6B-CF4A-BE52-0A6E441F82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E068E-69D6-6848-AD98-5D9C13A80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96248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9231E1-E8C7-1D45-BD6A-C4934C876F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9797650-EBEE-ED48-B6C1-3729E7D68C4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5DEC35F-A788-9845-B311-4735E35792D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FBCF0C4-ED0D-B949-9DEA-EF2412C033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505D0-96D5-4349-A1D1-681019D673D3}" type="datetimeFigureOut">
              <a:rPr lang="en-US" smtClean="0"/>
              <a:t>5/4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AC009D-5687-3849-90DD-2D5CA06904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FD3E507-18E0-AB45-BB0B-4A530B4743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E068E-69D6-6848-AD98-5D9C13A80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03225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0C7200-9C6A-844D-969D-94DE2B1507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0AE8321-E4C0-2B4E-ABBE-118333D22F2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F7E7571-EBAC-6346-B912-28F35D43F84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2CEF249-72DC-6943-AFB6-487774CB73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505D0-96D5-4349-A1D1-681019D673D3}" type="datetimeFigureOut">
              <a:rPr lang="en-US" smtClean="0"/>
              <a:t>5/4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C191803-8333-4441-959E-1989F2D375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07343F1-2A76-9A40-8512-6207E64029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E068E-69D6-6848-AD98-5D9C13A80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72096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C4264E4-1E6C-1F41-87E4-81EAC00E04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5C19CFC-C0F5-1842-B5EE-65794DF658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4A6164-4E7A-334E-ABB4-3C87EDE24E3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C505D0-96D5-4349-A1D1-681019D673D3}" type="datetimeFigureOut">
              <a:rPr lang="en-US" smtClean="0"/>
              <a:t>5/4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8354E6-7A5F-7B42-83A1-6092FE2965C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602E5D-B50E-E44D-8923-F6E74681ECE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EE068E-69D6-6848-AD98-5D9C13A80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23569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1" name="Google Shape;81;p2"/>
          <p:cNvGraphicFramePr/>
          <p:nvPr/>
        </p:nvGraphicFramePr>
        <p:xfrm>
          <a:off x="1558935" y="41073"/>
          <a:ext cx="9074091" cy="6775881"/>
        </p:xfrm>
        <a:graphic>
          <a:graphicData uri="http://schemas.openxmlformats.org/drawingml/2006/table">
            <a:tbl>
              <a:tblPr firstRow="1">
                <a:noFill/>
              </a:tblPr>
              <a:tblGrid>
                <a:gridCol w="138053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8768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2941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2941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02941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02941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02941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02941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1029410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846633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13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Protein</a:t>
                      </a:r>
                      <a:endParaRPr sz="1300"/>
                    </a:p>
                  </a:txBody>
                  <a:tcPr marL="44648" marR="44648" marT="0" marB="0" anchor="ctr">
                    <a:lnL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1300" b="1" i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N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13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Average percent fast phase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13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Average percent slow phase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1300" b="1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Percent fast and slow phase SD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Average fast rate, s</a:t>
                      </a:r>
                      <a:r>
                        <a:rPr lang="en-US" sz="1300" u="none" strike="noStrike" cap="none" baseline="30000"/>
                        <a:t>-1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Fast rate</a:t>
                      </a:r>
                      <a:endParaRPr sz="1300"/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SD, s</a:t>
                      </a:r>
                      <a:r>
                        <a:rPr lang="en-US" sz="1300" u="none" strike="noStrike" cap="none" baseline="30000"/>
                        <a:t>-1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1300" u="none" strike="noStrike" cap="none"/>
                        <a:t>Average slow rate, </a:t>
                      </a:r>
                      <a:endParaRPr sz="800" u="none" strike="noStrike" cap="none"/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1300" u="none" strike="noStrike" cap="none"/>
                        <a:t>s</a:t>
                      </a:r>
                      <a:r>
                        <a:rPr lang="en-US" sz="1300" u="none" strike="noStrike" cap="none" baseline="30000"/>
                        <a:t>-1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Slow rate SD, s</a:t>
                      </a:r>
                      <a:r>
                        <a:rPr lang="en-US" sz="1300" u="none" strike="noStrike" cap="none" baseline="30000"/>
                        <a:t>-1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94104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WT 25-hep</a:t>
                      </a:r>
                      <a:endParaRPr sz="1300"/>
                    </a:p>
                  </a:txBody>
                  <a:tcPr marL="44648" marR="44648" marT="0" marB="0" anchor="ctr">
                    <a:lnL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9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42.9%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57.1%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10.3%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185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121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0316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0055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94104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D778V 25-hep</a:t>
                      </a:r>
                      <a:endParaRPr sz="1300"/>
                    </a:p>
                  </a:txBody>
                  <a:tcPr marL="44648" marR="44648" marT="0" marB="0" anchor="ctr">
                    <a:lnL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8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36.3%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63.7%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10.0%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220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217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0342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0040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94104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L781P 25-hep</a:t>
                      </a:r>
                      <a:endParaRPr sz="1300"/>
                    </a:p>
                  </a:txBody>
                  <a:tcPr marL="44648" marR="44648" marT="0" marB="0" anchor="ctr">
                    <a:lnL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8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38.6%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61.4%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11.0%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154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057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0360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0027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94104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S782N 25-hep</a:t>
                      </a:r>
                      <a:endParaRPr sz="1300"/>
                    </a:p>
                  </a:txBody>
                  <a:tcPr marL="44648" marR="44648" marT="0" marB="0" anchor="ctr">
                    <a:lnL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8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32.2%*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67.8%*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5.2%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134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042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0328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0073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494104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A797T 25-hep</a:t>
                      </a:r>
                      <a:endParaRPr sz="1300"/>
                    </a:p>
                  </a:txBody>
                  <a:tcPr marL="44648" marR="44648" marT="0" marB="0" anchor="ctr">
                    <a:lnL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8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74.1%****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25.9%****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5.6%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113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010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0254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0074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494104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F834L 25-hep</a:t>
                      </a:r>
                      <a:endParaRPr sz="1300"/>
                    </a:p>
                  </a:txBody>
                  <a:tcPr marL="44648" marR="44648" marT="0" marB="0" anchor="ctr">
                    <a:lnL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7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83.7%****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16.3%****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4.0%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135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006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0270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0086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494104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WT 2-hep</a:t>
                      </a:r>
                      <a:endParaRPr sz="1300"/>
                    </a:p>
                  </a:txBody>
                  <a:tcPr marL="44648" marR="44648" marT="0" marB="0" anchor="ctr">
                    <a:lnL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10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79.1%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20.9%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4.9%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132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018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0196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0095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494104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D778V 2-hep</a:t>
                      </a:r>
                      <a:endParaRPr sz="1300"/>
                    </a:p>
                  </a:txBody>
                  <a:tcPr marL="44648" marR="44648" marT="0" marB="0" anchor="ctr">
                    <a:lnL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9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86.2%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16.3%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8.9%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135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016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0303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0155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494104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L781P 2-hep</a:t>
                      </a:r>
                      <a:endParaRPr sz="1300"/>
                    </a:p>
                  </a:txBody>
                  <a:tcPr marL="44648" marR="44648" marT="0" marB="0" anchor="ctr">
                    <a:lnL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7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76.9%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23.1%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2.3%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135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030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0167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0105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494104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S782N 2-hep</a:t>
                      </a:r>
                      <a:endParaRPr sz="1300"/>
                    </a:p>
                  </a:txBody>
                  <a:tcPr marL="44648" marR="44648" marT="0" marB="0" anchor="ctr">
                    <a:lnL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7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79.1%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20.9%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4.4%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150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020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0294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0108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494104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A797T 2-hep</a:t>
                      </a:r>
                      <a:endParaRPr sz="1300"/>
                    </a:p>
                  </a:txBody>
                  <a:tcPr marL="44648" marR="44648" marT="0" marB="0" anchor="ctr">
                    <a:lnL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4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82.2%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17.8%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6%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134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007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0184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0046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5D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494104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F834L 2-hep</a:t>
                      </a:r>
                      <a:endParaRPr sz="1300"/>
                    </a:p>
                  </a:txBody>
                  <a:tcPr marL="44648" marR="44648" marT="0" marB="0" anchor="ctr">
                    <a:lnL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4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73.6%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26.4%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5.0%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153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016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0253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900"/>
                        <a:buFont typeface="Arial"/>
                        <a:buNone/>
                      </a:pPr>
                      <a:r>
                        <a:rPr lang="en-US" sz="13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0.00148</a:t>
                      </a:r>
                      <a:endParaRPr sz="1300"/>
                    </a:p>
                  </a:txBody>
                  <a:tcPr marL="44648" marR="44648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2</Words>
  <Application>Microsoft Macintosh PowerPoint</Application>
  <PresentationFormat>Widescreen</PresentationFormat>
  <Paragraphs>11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 Neue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ke C</dc:creator>
  <cp:lastModifiedBy>Mike C</cp:lastModifiedBy>
  <cp:revision>1</cp:revision>
  <dcterms:created xsi:type="dcterms:W3CDTF">2022-05-04T20:43:38Z</dcterms:created>
  <dcterms:modified xsi:type="dcterms:W3CDTF">2022-05-04T20:44:03Z</dcterms:modified>
</cp:coreProperties>
</file>